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4607"/>
  </p:normalViewPr>
  <p:slideViewPr>
    <p:cSldViewPr snapToGrid="0" snapToObjects="1">
      <p:cViewPr varScale="1">
        <p:scale>
          <a:sx n="107" d="100"/>
          <a:sy n="107" d="100"/>
        </p:scale>
        <p:origin x="176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AD4E8C-2D0A-6C4F-939D-F091A8CC50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1705B6A-CF9F-E743-A195-011C9063F7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DAE8558-3AD8-024B-96F9-92BE17173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7F95B37F-2A01-5649-BFC2-BD37E1386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452B385B-817C-3C4F-AE08-287A2B916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58638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9CF856-5A71-F045-9B70-3F6F472D1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88761E56-6D1E-2A49-8532-04EFA3B4E8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A72CA40F-CA1A-7C46-9BF7-D21F6AFC1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2B12DD8-53FA-354F-BC4F-CFE398286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3CBCFE7-F895-334B-8DD2-45F56480E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98948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30E0244-D482-9148-8D57-F908168C65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EBA58278-17EE-8D4C-8801-85B14E0567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D33C8AA-BFA0-8B42-9A50-C7F2106F5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968B144-C324-6E41-8D4D-A07135C74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DF3A5EC-265C-BA4B-8778-C164D813B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1217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37B3ED-8567-E449-B97B-CC98E7A0C2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ED38050-8DC3-034B-87F3-8E43D602E2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80DEC24-AC51-4143-A450-3327EA02C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69D609EB-A961-7B4F-A8C3-04D79B79C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7DB1914-374E-8B46-AD0E-60EC07E2B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56573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1E1F5F-C9C2-8E47-8C2D-6B595EB574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FF9F4CF3-CF84-7D46-B60E-EB5E719CCD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A105E3C7-0571-D849-90E2-146B4B1C9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879984F3-C941-4140-96E5-7B497C5793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0C25B07-4CB0-9F4E-8836-5A3DE0CE8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77991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829E328-7396-D04F-A141-A472C4E8A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ABF04D9-3219-D342-9B6C-18B7D413FD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8E8F3102-D4F5-FA41-83AD-F2A7CEAE19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9B708059-BA0F-084B-9C2A-F00311B09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560CFC1F-AE2A-FE4D-90D1-A11263118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277E10CB-564C-3849-9510-5A4C0ED23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12255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E4F0D0-2CD1-1640-9A61-DFAEE5CD62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8C0F09F4-79D5-304B-ABFF-BC51306B9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D2346765-0F39-4B4B-A1E2-CB7DAD2C79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15415BBA-D8A5-8747-BF4D-CEC93C958A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E1869432-5FA7-F540-BDDC-73BD9758CC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DB9D71D6-AA09-6046-B179-A9AA63396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417C6B00-94BE-5E48-97EA-D33292A9B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F3E517D4-362F-CD43-ACC2-A405C3B6D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42431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727EC6-CE5E-4A48-A427-03B4E9A854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03AF1222-77C2-5242-AB93-5FFC453D3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279F6C63-BFAF-614C-8A02-385409743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18817782-58BC-024A-9DDB-05168BB4C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833418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19EA2ED4-485F-8A4C-A83D-8FA59096C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CD4D7608-3306-B546-8F60-3EB5E4ACB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9D9F3A19-CE50-534C-B50B-B3814772C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49225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842210-C6F6-E347-97EB-621213D61F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D8F841E6-DE5B-2F4B-B8CC-EBD812A235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0FA23459-B08E-844F-A618-79FC1275D6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005448A0-1A80-2B4A-8EBB-38409DE4E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BB3F2B0E-6432-4746-900A-70301F6A9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8B456C2C-8D47-6B4E-91E2-68EBD2422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86467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A7924C-995E-EF46-BF90-C5FBF92850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F3AE478B-8FE9-604F-AD20-8569794C19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AD685FDD-87DF-E44D-83EA-B229E21AB9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2898880B-4052-9A4A-B2EB-8966E59D4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52833C5A-1477-0D4B-9708-ADF5BA147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DEC3A4CA-E1FE-EF47-A710-7B0E152E6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15813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DA1DD167-D823-6942-B6A6-20FE6F2DD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813A6868-D021-864A-8DFB-3F32BCBE2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8CE3C638-29C7-EB41-9ADE-A1FF52336A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677091-4D2C-AB49-8C62-E8A41D0D4114}" type="datetimeFigureOut">
              <a:rPr lang="pt-PT" smtClean="0"/>
              <a:t>27/02/25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3B0708FE-4568-084C-A07F-7DD79023C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90E87B73-F56B-2946-942B-B62CA601E5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9CA22F-8C62-B946-9211-2103CD098A9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80368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ixa de Texto 11">
            <a:extLst>
              <a:ext uri="{FF2B5EF4-FFF2-40B4-BE49-F238E27FC236}">
                <a16:creationId xmlns:a16="http://schemas.microsoft.com/office/drawing/2014/main" id="{1FD137AD-AAC9-834A-9552-BF95B75094D7}"/>
              </a:ext>
            </a:extLst>
          </p:cNvPr>
          <p:cNvSpPr txBox="1"/>
          <p:nvPr/>
        </p:nvSpPr>
        <p:spPr>
          <a:xfrm>
            <a:off x="461854" y="5631413"/>
            <a:ext cx="11156405" cy="629724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US" sz="110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 – Variation in total </a:t>
            </a:r>
            <a:r>
              <a:rPr lang="en-US" sz="1100" i="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PRA</a:t>
            </a:r>
            <a:r>
              <a:rPr lang="en-US" sz="110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onsidering a MFI of 2000 as cutoff for unacceptable antigen, for Rapid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10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thdrawal and Prolonged CNI groups, as predicted by the fitted mixed model. Solid lines represent the predicted </a:t>
            </a:r>
            <a:r>
              <a:rPr lang="en-US" sz="1100" i="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PRA</a:t>
            </a:r>
            <a:r>
              <a:rPr lang="en-US" sz="110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evel at the time point in the x axis and the shaded areas are 95% confident intervals.</a:t>
            </a:r>
            <a:endParaRPr lang="pt-PT" sz="1100" i="1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Imagem 12">
            <a:extLst>
              <a:ext uri="{FF2B5EF4-FFF2-40B4-BE49-F238E27FC236}">
                <a16:creationId xmlns:a16="http://schemas.microsoft.com/office/drawing/2014/main" id="{C23B2B07-976B-AE84-351F-16016B17B2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0672" y="596863"/>
            <a:ext cx="6181344" cy="4636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57751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>
            <a:extLst>
              <a:ext uri="{FF2B5EF4-FFF2-40B4-BE49-F238E27FC236}">
                <a16:creationId xmlns:a16="http://schemas.microsoft.com/office/drawing/2014/main" id="{A01B64A3-0931-5241-8651-194648528894}"/>
              </a:ext>
            </a:extLst>
          </p:cNvPr>
          <p:cNvSpPr txBox="1"/>
          <p:nvPr/>
        </p:nvSpPr>
        <p:spPr>
          <a:xfrm>
            <a:off x="293256" y="5769564"/>
            <a:ext cx="11202784" cy="7219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 – Variation in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PRA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roups according to the immunosuppressive therapy withdrawal strategy and the baseline level of HLA sensitization. A- variation between T0 and T6; B- variation between T6 and T12; C-variation between T0 and T12.</a:t>
            </a:r>
            <a:endParaRPr lang="pt-PT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1" name="Agrupar 20">
            <a:extLst>
              <a:ext uri="{FF2B5EF4-FFF2-40B4-BE49-F238E27FC236}">
                <a16:creationId xmlns:a16="http://schemas.microsoft.com/office/drawing/2014/main" id="{DD57AC1E-7F5A-871B-9093-7AE4126ABD15}"/>
              </a:ext>
            </a:extLst>
          </p:cNvPr>
          <p:cNvGrpSpPr/>
          <p:nvPr/>
        </p:nvGrpSpPr>
        <p:grpSpPr>
          <a:xfrm>
            <a:off x="582826" y="404421"/>
            <a:ext cx="11418674" cy="5135259"/>
            <a:chOff x="582826" y="404421"/>
            <a:chExt cx="11418674" cy="5135259"/>
          </a:xfrm>
        </p:grpSpPr>
        <p:pic>
          <p:nvPicPr>
            <p:cNvPr id="5" name="Picture 12">
              <a:extLst>
                <a:ext uri="{FF2B5EF4-FFF2-40B4-BE49-F238E27FC236}">
                  <a16:creationId xmlns:a16="http://schemas.microsoft.com/office/drawing/2014/main" id="{4CF15A85-F3D7-974B-86A8-D5A6B0F447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1460" y="404421"/>
              <a:ext cx="5400040" cy="2456815"/>
            </a:xfrm>
            <a:prstGeom prst="rect">
              <a:avLst/>
            </a:prstGeom>
          </p:spPr>
        </p:pic>
        <p:pic>
          <p:nvPicPr>
            <p:cNvPr id="6" name="Picture 13">
              <a:extLst>
                <a:ext uri="{FF2B5EF4-FFF2-40B4-BE49-F238E27FC236}">
                  <a16:creationId xmlns:a16="http://schemas.microsoft.com/office/drawing/2014/main" id="{FCE30174-F02F-704A-BF71-496A23736FC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5980" y="3091120"/>
              <a:ext cx="5400040" cy="2448560"/>
            </a:xfrm>
            <a:prstGeom prst="rect">
              <a:avLst/>
            </a:prstGeom>
          </p:spPr>
        </p:pic>
        <p:grpSp>
          <p:nvGrpSpPr>
            <p:cNvPr id="3" name="Agrupar 2">
              <a:extLst>
                <a:ext uri="{FF2B5EF4-FFF2-40B4-BE49-F238E27FC236}">
                  <a16:creationId xmlns:a16="http://schemas.microsoft.com/office/drawing/2014/main" id="{E8918D28-3D02-B841-B576-84924F7183AA}"/>
                </a:ext>
              </a:extLst>
            </p:cNvPr>
            <p:cNvGrpSpPr/>
            <p:nvPr/>
          </p:nvGrpSpPr>
          <p:grpSpPr>
            <a:xfrm>
              <a:off x="582826" y="404421"/>
              <a:ext cx="5400040" cy="2558415"/>
              <a:chOff x="494608" y="404421"/>
              <a:chExt cx="5400040" cy="2558415"/>
            </a:xfrm>
          </p:grpSpPr>
          <p:pic>
            <p:nvPicPr>
              <p:cNvPr id="4" name="Picture 11">
                <a:extLst>
                  <a:ext uri="{FF2B5EF4-FFF2-40B4-BE49-F238E27FC236}">
                    <a16:creationId xmlns:a16="http://schemas.microsoft.com/office/drawing/2014/main" id="{C1A6383A-DFCD-A746-BDA5-F383D89552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4608" y="404421"/>
                <a:ext cx="5400040" cy="2558415"/>
              </a:xfrm>
              <a:prstGeom prst="rect">
                <a:avLst/>
              </a:prstGeom>
            </p:spPr>
          </p:pic>
          <p:sp>
            <p:nvSpPr>
              <p:cNvPr id="2" name="Retângulo 1">
                <a:extLst>
                  <a:ext uri="{FF2B5EF4-FFF2-40B4-BE49-F238E27FC236}">
                    <a16:creationId xmlns:a16="http://schemas.microsoft.com/office/drawing/2014/main" id="{AEC6AEA5-FB8E-AE48-ABCE-C6419194CFD1}"/>
                  </a:ext>
                </a:extLst>
              </p:cNvPr>
              <p:cNvSpPr/>
              <p:nvPr/>
            </p:nvSpPr>
            <p:spPr>
              <a:xfrm>
                <a:off x="1282700" y="2590800"/>
                <a:ext cx="609600" cy="21963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pt-PT" sz="800" dirty="0">
                    <a:solidFill>
                      <a:schemeClr val="bg2">
                        <a:lumMod val="50000"/>
                      </a:schemeClr>
                    </a:solidFill>
                  </a:rPr>
                  <a:t>0-19%</a:t>
                </a:r>
              </a:p>
            </p:txBody>
          </p:sp>
          <p:sp>
            <p:nvSpPr>
              <p:cNvPr id="8" name="Retângulo 7">
                <a:extLst>
                  <a:ext uri="{FF2B5EF4-FFF2-40B4-BE49-F238E27FC236}">
                    <a16:creationId xmlns:a16="http://schemas.microsoft.com/office/drawing/2014/main" id="{11084F67-7714-614B-AEAA-9E4416EC8F31}"/>
                  </a:ext>
                </a:extLst>
              </p:cNvPr>
              <p:cNvSpPr/>
              <p:nvPr/>
            </p:nvSpPr>
            <p:spPr>
              <a:xfrm>
                <a:off x="2710180" y="2590800"/>
                <a:ext cx="609600" cy="21963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pt-PT" sz="800" dirty="0">
                    <a:solidFill>
                      <a:schemeClr val="bg2">
                        <a:lumMod val="50000"/>
                      </a:schemeClr>
                    </a:solidFill>
                  </a:rPr>
                  <a:t>20-84%</a:t>
                </a:r>
              </a:p>
            </p:txBody>
          </p:sp>
          <p:sp>
            <p:nvSpPr>
              <p:cNvPr id="9" name="Retângulo 8">
                <a:extLst>
                  <a:ext uri="{FF2B5EF4-FFF2-40B4-BE49-F238E27FC236}">
                    <a16:creationId xmlns:a16="http://schemas.microsoft.com/office/drawing/2014/main" id="{4C47A85A-865D-9F4F-B440-13A84DC1216F}"/>
                  </a:ext>
                </a:extLst>
              </p:cNvPr>
              <p:cNvSpPr/>
              <p:nvPr/>
            </p:nvSpPr>
            <p:spPr>
              <a:xfrm>
                <a:off x="4142740" y="2590800"/>
                <a:ext cx="609600" cy="21963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pt-PT" sz="800" dirty="0">
                    <a:solidFill>
                      <a:schemeClr val="bg2">
                        <a:lumMod val="50000"/>
                      </a:schemeClr>
                    </a:solidFill>
                  </a:rPr>
                  <a:t>85-97%</a:t>
                </a:r>
              </a:p>
            </p:txBody>
          </p:sp>
        </p:grpSp>
      </p:grpSp>
      <p:grpSp>
        <p:nvGrpSpPr>
          <p:cNvPr id="16" name="Agrupar 15">
            <a:extLst>
              <a:ext uri="{FF2B5EF4-FFF2-40B4-BE49-F238E27FC236}">
                <a16:creationId xmlns:a16="http://schemas.microsoft.com/office/drawing/2014/main" id="{F9069177-E5B4-1C49-B59D-44FD28C730A9}"/>
              </a:ext>
            </a:extLst>
          </p:cNvPr>
          <p:cNvGrpSpPr/>
          <p:nvPr/>
        </p:nvGrpSpPr>
        <p:grpSpPr>
          <a:xfrm>
            <a:off x="7302500" y="2582582"/>
            <a:ext cx="3431540" cy="84418"/>
            <a:chOff x="7302500" y="2582582"/>
            <a:chExt cx="3431540" cy="84418"/>
          </a:xfrm>
        </p:grpSpPr>
        <p:sp>
          <p:nvSpPr>
            <p:cNvPr id="10" name="Retângulo 9">
              <a:extLst>
                <a:ext uri="{FF2B5EF4-FFF2-40B4-BE49-F238E27FC236}">
                  <a16:creationId xmlns:a16="http://schemas.microsoft.com/office/drawing/2014/main" id="{E36B66C7-E005-F74E-B46E-A40694BD4075}"/>
                </a:ext>
              </a:extLst>
            </p:cNvPr>
            <p:cNvSpPr/>
            <p:nvPr/>
          </p:nvSpPr>
          <p:spPr>
            <a:xfrm>
              <a:off x="7302500" y="2582582"/>
              <a:ext cx="571500" cy="844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PT" sz="800" dirty="0">
                  <a:solidFill>
                    <a:schemeClr val="bg2">
                      <a:lumMod val="50000"/>
                    </a:schemeClr>
                  </a:solidFill>
                </a:rPr>
                <a:t>0-19%</a:t>
              </a:r>
            </a:p>
          </p:txBody>
        </p:sp>
        <p:sp>
          <p:nvSpPr>
            <p:cNvPr id="11" name="Retângulo 10">
              <a:extLst>
                <a:ext uri="{FF2B5EF4-FFF2-40B4-BE49-F238E27FC236}">
                  <a16:creationId xmlns:a16="http://schemas.microsoft.com/office/drawing/2014/main" id="{30D3949E-E43B-A74A-9932-5F5020E3C45C}"/>
                </a:ext>
              </a:extLst>
            </p:cNvPr>
            <p:cNvSpPr/>
            <p:nvPr/>
          </p:nvSpPr>
          <p:spPr>
            <a:xfrm>
              <a:off x="8729980" y="2582582"/>
              <a:ext cx="571500" cy="844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PT" sz="800" dirty="0">
                  <a:solidFill>
                    <a:schemeClr val="bg2">
                      <a:lumMod val="50000"/>
                    </a:schemeClr>
                  </a:solidFill>
                </a:rPr>
                <a:t>20-84%</a:t>
              </a:r>
            </a:p>
          </p:txBody>
        </p:sp>
        <p:sp>
          <p:nvSpPr>
            <p:cNvPr id="12" name="Retângulo 11">
              <a:extLst>
                <a:ext uri="{FF2B5EF4-FFF2-40B4-BE49-F238E27FC236}">
                  <a16:creationId xmlns:a16="http://schemas.microsoft.com/office/drawing/2014/main" id="{D3B2240D-1A8A-7649-BD68-BB4B845675A0}"/>
                </a:ext>
              </a:extLst>
            </p:cNvPr>
            <p:cNvSpPr/>
            <p:nvPr/>
          </p:nvSpPr>
          <p:spPr>
            <a:xfrm>
              <a:off x="10162540" y="2582582"/>
              <a:ext cx="571500" cy="844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PT" sz="800" dirty="0">
                  <a:solidFill>
                    <a:schemeClr val="bg2">
                      <a:lumMod val="50000"/>
                    </a:schemeClr>
                  </a:solidFill>
                </a:rPr>
                <a:t>85-97%</a:t>
              </a:r>
            </a:p>
          </p:txBody>
        </p:sp>
      </p:grpSp>
      <p:grpSp>
        <p:nvGrpSpPr>
          <p:cNvPr id="17" name="Agrupar 16">
            <a:extLst>
              <a:ext uri="{FF2B5EF4-FFF2-40B4-BE49-F238E27FC236}">
                <a16:creationId xmlns:a16="http://schemas.microsoft.com/office/drawing/2014/main" id="{EE0D03F6-556A-CD40-A8E5-0637285F5CEC}"/>
              </a:ext>
            </a:extLst>
          </p:cNvPr>
          <p:cNvGrpSpPr/>
          <p:nvPr/>
        </p:nvGrpSpPr>
        <p:grpSpPr>
          <a:xfrm>
            <a:off x="4193540" y="5249582"/>
            <a:ext cx="3431540" cy="84418"/>
            <a:chOff x="4193540" y="5249582"/>
            <a:chExt cx="3431540" cy="84418"/>
          </a:xfrm>
        </p:grpSpPr>
        <p:sp>
          <p:nvSpPr>
            <p:cNvPr id="13" name="Retângulo 12">
              <a:extLst>
                <a:ext uri="{FF2B5EF4-FFF2-40B4-BE49-F238E27FC236}">
                  <a16:creationId xmlns:a16="http://schemas.microsoft.com/office/drawing/2014/main" id="{5D35B7D6-997D-BC4C-8C1A-2BDFFC72B648}"/>
                </a:ext>
              </a:extLst>
            </p:cNvPr>
            <p:cNvSpPr/>
            <p:nvPr/>
          </p:nvSpPr>
          <p:spPr>
            <a:xfrm>
              <a:off x="4193540" y="5249582"/>
              <a:ext cx="571500" cy="844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PT" sz="800" dirty="0">
                  <a:solidFill>
                    <a:schemeClr val="bg2">
                      <a:lumMod val="50000"/>
                    </a:schemeClr>
                  </a:solidFill>
                </a:rPr>
                <a:t>0-19%</a:t>
              </a:r>
            </a:p>
          </p:txBody>
        </p:sp>
        <p:sp>
          <p:nvSpPr>
            <p:cNvPr id="14" name="Retângulo 13">
              <a:extLst>
                <a:ext uri="{FF2B5EF4-FFF2-40B4-BE49-F238E27FC236}">
                  <a16:creationId xmlns:a16="http://schemas.microsoft.com/office/drawing/2014/main" id="{DAA15F08-6D6A-9142-AF5B-D743374E7973}"/>
                </a:ext>
              </a:extLst>
            </p:cNvPr>
            <p:cNvSpPr/>
            <p:nvPr/>
          </p:nvSpPr>
          <p:spPr>
            <a:xfrm>
              <a:off x="5621020" y="5249582"/>
              <a:ext cx="571500" cy="844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PT" sz="800" dirty="0">
                  <a:solidFill>
                    <a:schemeClr val="bg2">
                      <a:lumMod val="50000"/>
                    </a:schemeClr>
                  </a:solidFill>
                </a:rPr>
                <a:t>20-84%</a:t>
              </a:r>
            </a:p>
          </p:txBody>
        </p:sp>
        <p:sp>
          <p:nvSpPr>
            <p:cNvPr id="15" name="Retângulo 14">
              <a:extLst>
                <a:ext uri="{FF2B5EF4-FFF2-40B4-BE49-F238E27FC236}">
                  <a16:creationId xmlns:a16="http://schemas.microsoft.com/office/drawing/2014/main" id="{A8F85BD1-079F-3440-92CB-21E8F236D775}"/>
                </a:ext>
              </a:extLst>
            </p:cNvPr>
            <p:cNvSpPr/>
            <p:nvPr/>
          </p:nvSpPr>
          <p:spPr>
            <a:xfrm>
              <a:off x="7053580" y="5249582"/>
              <a:ext cx="571500" cy="844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PT" sz="800" dirty="0">
                  <a:solidFill>
                    <a:schemeClr val="bg2">
                      <a:lumMod val="50000"/>
                    </a:schemeClr>
                  </a:solidFill>
                </a:rPr>
                <a:t>85-97%</a:t>
              </a:r>
            </a:p>
          </p:txBody>
        </p:sp>
      </p:grpSp>
      <p:sp>
        <p:nvSpPr>
          <p:cNvPr id="18" name="CaixaDeTexto 7">
            <a:extLst>
              <a:ext uri="{FF2B5EF4-FFF2-40B4-BE49-F238E27FC236}">
                <a16:creationId xmlns:a16="http://schemas.microsoft.com/office/drawing/2014/main" id="{631CAC53-5876-6E44-A341-3E6127F15223}"/>
              </a:ext>
            </a:extLst>
          </p:cNvPr>
          <p:cNvSpPr txBox="1"/>
          <p:nvPr/>
        </p:nvSpPr>
        <p:spPr>
          <a:xfrm>
            <a:off x="461854" y="355563"/>
            <a:ext cx="232422" cy="27498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pt-PT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pt-P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CaixaDeTexto 8">
            <a:extLst>
              <a:ext uri="{FF2B5EF4-FFF2-40B4-BE49-F238E27FC236}">
                <a16:creationId xmlns:a16="http://schemas.microsoft.com/office/drawing/2014/main" id="{5A23A57A-784C-C04A-B192-927F27B4C3E4}"/>
              </a:ext>
            </a:extLst>
          </p:cNvPr>
          <p:cNvSpPr txBox="1"/>
          <p:nvPr/>
        </p:nvSpPr>
        <p:spPr>
          <a:xfrm>
            <a:off x="6821158" y="355563"/>
            <a:ext cx="232422" cy="27498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pt-PT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pt-P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CaixaDeTexto 9">
            <a:extLst>
              <a:ext uri="{FF2B5EF4-FFF2-40B4-BE49-F238E27FC236}">
                <a16:creationId xmlns:a16="http://schemas.microsoft.com/office/drawing/2014/main" id="{40C99BA7-0BB3-3340-B33E-29E1D2A2F437}"/>
              </a:ext>
            </a:extLst>
          </p:cNvPr>
          <p:cNvSpPr txBox="1"/>
          <p:nvPr/>
        </p:nvSpPr>
        <p:spPr>
          <a:xfrm>
            <a:off x="3675996" y="3146614"/>
            <a:ext cx="232422" cy="27498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pt-PT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pt-PT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87903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23</TotalTime>
  <Words>123</Words>
  <Application>Microsoft Macintosh PowerPoint</Application>
  <PresentationFormat>Ecrã Panorâmico</PresentationFormat>
  <Paragraphs>14</Paragraphs>
  <Slides>2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o Office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Rita Leal</dc:creator>
  <cp:lastModifiedBy>Rita Leal</cp:lastModifiedBy>
  <cp:revision>25</cp:revision>
  <dcterms:created xsi:type="dcterms:W3CDTF">2024-05-29T12:44:35Z</dcterms:created>
  <dcterms:modified xsi:type="dcterms:W3CDTF">2025-02-27T23:21:45Z</dcterms:modified>
</cp:coreProperties>
</file>